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67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A9768D5-7129-15FE-7EB1-F2E9011B261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BE790E5-5168-BA8C-244C-88CFAAAEAA0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693B19B-E79C-6B61-680B-D875B6B2A3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49A1E-1160-4CCE-B99E-4CE1BE0B39C9}" type="datetimeFigureOut">
              <a:rPr lang="zh-CN" altLang="en-US" smtClean="0"/>
              <a:t>2024/7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A134E30-DF0B-88E3-A318-F335A07CC4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11EF802-C4C6-910C-4FC3-AD1A364D6C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4DC3E-B251-428C-A01B-49C6EF2C5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1782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FBC0C5-3CF3-1A3E-3533-33913F09A7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D91B4EE-B6B4-F6A9-AFC4-1677572733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10C567-58CD-B8FC-2D37-ED0927471F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49A1E-1160-4CCE-B99E-4CE1BE0B39C9}" type="datetimeFigureOut">
              <a:rPr lang="zh-CN" altLang="en-US" smtClean="0"/>
              <a:t>2024/7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8FBFBEE-C6CA-4860-EFF9-FB7365ED97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F61E588-2E3B-07C1-61D4-EC25BF1A41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4DC3E-B251-428C-A01B-49C6EF2C5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0401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CF46938-22AD-08F9-4F8E-04E3532D5C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894907E-4E56-864A-F603-367C25F359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9ACCE22-EC71-33C4-E904-AC540EC6FC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49A1E-1160-4CCE-B99E-4CE1BE0B39C9}" type="datetimeFigureOut">
              <a:rPr lang="zh-CN" altLang="en-US" smtClean="0"/>
              <a:t>2024/7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BDF3AAF-540F-2AEA-195B-3A500994B7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42A441A-AE39-EA30-4FE9-9FEEF19E05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4DC3E-B251-428C-A01B-49C6EF2C5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11898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0ECD88-BEB6-D6C0-C33D-F3318F4554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F407BF4-45BD-73EE-3F25-08BE423365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0EB4852-E293-0D9A-33DF-B68519C775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49A1E-1160-4CCE-B99E-4CE1BE0B39C9}" type="datetimeFigureOut">
              <a:rPr lang="zh-CN" altLang="en-US" smtClean="0"/>
              <a:t>2024/7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B133746-5A99-FB4B-4401-A41EB9E2A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5148F13-DF32-7B0F-3F86-99DC829DAB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4DC3E-B251-428C-A01B-49C6EF2C5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62087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7119D9-A7C1-4C57-0325-E39192513A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456DC49-04AD-DAB6-D1BB-F65E4A3A3C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9C82AE9-6FF5-818C-B22D-4D0A73A7D5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49A1E-1160-4CCE-B99E-4CE1BE0B39C9}" type="datetimeFigureOut">
              <a:rPr lang="zh-CN" altLang="en-US" smtClean="0"/>
              <a:t>2024/7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B2C57D7-0DDB-702C-271F-92852D155E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70EED72-9706-1C01-86D1-C2BCBE249C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4DC3E-B251-428C-A01B-49C6EF2C5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3197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B944BBA-D413-D2D7-6A79-7D54062535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B47E6D1-3E20-897E-4C5B-3600C6FE8A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95C909B-5B6C-0634-D68A-6292D34496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0919D10-2C6E-9534-52AC-53163CE5AF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49A1E-1160-4CCE-B99E-4CE1BE0B39C9}" type="datetimeFigureOut">
              <a:rPr lang="zh-CN" altLang="en-US" smtClean="0"/>
              <a:t>2024/7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5DACBE7-C771-4DD7-8261-734AC23C04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D29C03B-4D3D-4343-0E0B-D02AC6EFC9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4DC3E-B251-428C-A01B-49C6EF2C5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148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CE18B1-2404-E827-AEA3-CAA6E25702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18AA6FC-E52B-E54F-B4C0-C8D4950C87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6265282-DDC0-A4E5-A523-FB57DE89C8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0CF900D-D032-52A2-541F-CFBE91D2EE5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521393E-3814-6B30-B300-2AB475C138F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D3E6A68-74D3-D869-D214-EB97799BFE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49A1E-1160-4CCE-B99E-4CE1BE0B39C9}" type="datetimeFigureOut">
              <a:rPr lang="zh-CN" altLang="en-US" smtClean="0"/>
              <a:t>2024/7/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B9B613B-63B8-D3F7-6B85-376AEF9BD4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A42EAA4-53B3-528C-F57B-4B6D7454D7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4DC3E-B251-428C-A01B-49C6EF2C5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50982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C887208-6BD5-D1F8-0DF0-E2DFC4518F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10B918D-02BA-441E-B7E5-AE9F93A9BF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49A1E-1160-4CCE-B99E-4CE1BE0B39C9}" type="datetimeFigureOut">
              <a:rPr lang="zh-CN" altLang="en-US" smtClean="0"/>
              <a:t>2024/7/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1A57D8A-219E-8702-7CA5-70CBE7D786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6EF2E0A-88CF-1198-8EEA-900EE5D6EE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4DC3E-B251-428C-A01B-49C6EF2C5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65339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E7A3DEC-1BED-E7F5-3974-E89EBDC77A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49A1E-1160-4CCE-B99E-4CE1BE0B39C9}" type="datetimeFigureOut">
              <a:rPr lang="zh-CN" altLang="en-US" smtClean="0"/>
              <a:t>2024/7/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30A9582-E6C1-3FAC-6FA8-C4DF07EF31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9B8DF65-84EF-6164-2D0A-D73CE4A684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4DC3E-B251-428C-A01B-49C6EF2C5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56197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6334A77-36C4-5C9C-1C2B-4BB1377B0C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E2BFFC8-141A-EBE9-E036-D8C5A81E11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226E05E-EAF9-1C54-895B-E78F66E789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C661F45-CEBA-3B41-51F5-3FC0AFE1BF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49A1E-1160-4CCE-B99E-4CE1BE0B39C9}" type="datetimeFigureOut">
              <a:rPr lang="zh-CN" altLang="en-US" smtClean="0"/>
              <a:t>2024/7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B354925-D765-EAB5-EBBE-8C76E3C022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97853B7-DEE2-528E-0156-A870838B7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4DC3E-B251-428C-A01B-49C6EF2C5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3638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272FC4-A24E-0DEA-3B9B-5956C9D05E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39B92BE-E420-B971-5942-AAC2DA7FE1F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88261DC-DD3B-8559-71D1-FC4B5099EF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DEFBD2E-EB94-07DD-0084-96DE2F096D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49A1E-1160-4CCE-B99E-4CE1BE0B39C9}" type="datetimeFigureOut">
              <a:rPr lang="zh-CN" altLang="en-US" smtClean="0"/>
              <a:t>2024/7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7805590-B6E1-33DC-0AF7-652CBA3BF9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AF76A32-6E05-88A6-DE1C-EAFCBEBE6F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44DC3E-B251-428C-A01B-49C6EF2C5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1305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C309F3F-27F4-AEFB-D25B-A0C6954AB1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83F7F8B-BCB8-83BA-5DC8-A47A68AFE2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0069BA8-CB49-DF27-F957-B7A0013C96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0C49A1E-1160-4CCE-B99E-4CE1BE0B39C9}" type="datetimeFigureOut">
              <a:rPr lang="zh-CN" altLang="en-US" smtClean="0"/>
              <a:t>2024/7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24E3C24-FBDB-B48C-7D61-EA377457602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A4A473F-117E-3E0B-A8C0-F077862D7E9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244DC3E-B251-428C-A01B-49C6EF2C56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30655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tags" Target="../tags/tag8.xml"/><Relationship Id="rId13" Type="http://schemas.openxmlformats.org/officeDocument/2006/relationships/tags" Target="../tags/tag13.xml"/><Relationship Id="rId18" Type="http://schemas.openxmlformats.org/officeDocument/2006/relationships/image" Target="../media/image1.jpeg"/><Relationship Id="rId3" Type="http://schemas.openxmlformats.org/officeDocument/2006/relationships/tags" Target="../tags/tag3.xml"/><Relationship Id="rId21" Type="http://schemas.openxmlformats.org/officeDocument/2006/relationships/image" Target="../media/image4.jpeg"/><Relationship Id="rId7" Type="http://schemas.openxmlformats.org/officeDocument/2006/relationships/tags" Target="../tags/tag7.xml"/><Relationship Id="rId12" Type="http://schemas.openxmlformats.org/officeDocument/2006/relationships/tags" Target="../tags/tag12.xml"/><Relationship Id="rId17" Type="http://schemas.openxmlformats.org/officeDocument/2006/relationships/slideLayout" Target="../slideLayouts/slideLayout1.xml"/><Relationship Id="rId2" Type="http://schemas.openxmlformats.org/officeDocument/2006/relationships/tags" Target="../tags/tag2.xml"/><Relationship Id="rId16" Type="http://schemas.openxmlformats.org/officeDocument/2006/relationships/tags" Target="../tags/tag16.xml"/><Relationship Id="rId20" Type="http://schemas.openxmlformats.org/officeDocument/2006/relationships/image" Target="../media/image3.jpeg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1" Type="http://schemas.openxmlformats.org/officeDocument/2006/relationships/tags" Target="../tags/tag11.xml"/><Relationship Id="rId5" Type="http://schemas.openxmlformats.org/officeDocument/2006/relationships/tags" Target="../tags/tag5.xml"/><Relationship Id="rId15" Type="http://schemas.openxmlformats.org/officeDocument/2006/relationships/tags" Target="../tags/tag15.xml"/><Relationship Id="rId10" Type="http://schemas.openxmlformats.org/officeDocument/2006/relationships/tags" Target="../tags/tag10.xml"/><Relationship Id="rId19" Type="http://schemas.openxmlformats.org/officeDocument/2006/relationships/image" Target="../media/image2.jpeg"/><Relationship Id="rId4" Type="http://schemas.openxmlformats.org/officeDocument/2006/relationships/tags" Target="../tags/tag4.xml"/><Relationship Id="rId9" Type="http://schemas.openxmlformats.org/officeDocument/2006/relationships/tags" Target="../tags/tag9.xml"/><Relationship Id="rId14" Type="http://schemas.openxmlformats.org/officeDocument/2006/relationships/tags" Target="../tags/tag14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tags" Target="../tags/tag24.xml"/><Relationship Id="rId3" Type="http://schemas.openxmlformats.org/officeDocument/2006/relationships/tags" Target="../tags/tag19.xml"/><Relationship Id="rId7" Type="http://schemas.openxmlformats.org/officeDocument/2006/relationships/tags" Target="../tags/tag23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tags" Target="../tags/tag22.xml"/><Relationship Id="rId11" Type="http://schemas.openxmlformats.org/officeDocument/2006/relationships/image" Target="../media/image6.jpeg"/><Relationship Id="rId5" Type="http://schemas.openxmlformats.org/officeDocument/2006/relationships/tags" Target="../tags/tag21.xml"/><Relationship Id="rId10" Type="http://schemas.openxmlformats.org/officeDocument/2006/relationships/image" Target="../media/image5.jpeg"/><Relationship Id="rId4" Type="http://schemas.openxmlformats.org/officeDocument/2006/relationships/tags" Target="../tags/tag20.xml"/><Relationship Id="rId9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jiexian 2023-09-27 17h18m04s(Composite)">
            <a:extLst>
              <a:ext uri="{FF2B5EF4-FFF2-40B4-BE49-F238E27FC236}">
                <a16:creationId xmlns:a16="http://schemas.microsoft.com/office/drawing/2014/main" id="{0C55F178-2072-86ED-CAE6-2FDFAF7C5DA6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39624" t="24446" r="32437" b="39106"/>
          <a:stretch/>
        </p:blipFill>
        <p:spPr>
          <a:xfrm flipH="1">
            <a:off x="1466091" y="1102659"/>
            <a:ext cx="3039308" cy="2397611"/>
          </a:xfrm>
          <a:prstGeom prst="rect">
            <a:avLst/>
          </a:prstGeom>
        </p:spPr>
      </p:pic>
      <p:pic>
        <p:nvPicPr>
          <p:cNvPr id="5" name="图片 4" descr="jiexian 2023-09-27 17h32m30s(Composite)">
            <a:extLst>
              <a:ext uri="{FF2B5EF4-FFF2-40B4-BE49-F238E27FC236}">
                <a16:creationId xmlns:a16="http://schemas.microsoft.com/office/drawing/2014/main" id="{E50CA0C0-42FB-E1EE-B222-D913CF0F9BFE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l="31073" t="20560" r="45328" b="55717"/>
          <a:stretch/>
        </p:blipFill>
        <p:spPr>
          <a:xfrm flipH="1">
            <a:off x="6966570" y="1223797"/>
            <a:ext cx="2759037" cy="2219054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5512B5B8-DE47-D17F-7D44-EF64722B2141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 rot="18420000">
            <a:off x="2318333" y="604140"/>
            <a:ext cx="915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EC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9D0D78D2-53BC-C28E-20E1-52E9E06D8157}"/>
              </a:ext>
            </a:extLst>
          </p:cNvPr>
          <p:cNvSpPr txBox="1"/>
          <p:nvPr>
            <p:custDataLst>
              <p:tags r:id="rId2"/>
            </p:custDataLst>
          </p:nvPr>
        </p:nvSpPr>
        <p:spPr>
          <a:xfrm rot="18420000">
            <a:off x="2508543" y="187531"/>
            <a:ext cx="19589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EC1-ROR1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V3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E357F09-5B7F-5623-1278-1859636284E9}"/>
              </a:ext>
            </a:extLst>
          </p:cNvPr>
          <p:cNvSpPr txBox="1"/>
          <p:nvPr>
            <p:custDataLst>
              <p:tags r:id="rId3"/>
            </p:custDataLst>
          </p:nvPr>
        </p:nvSpPr>
        <p:spPr>
          <a:xfrm rot="18420000">
            <a:off x="3051896" y="392788"/>
            <a:ext cx="1550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EC1-ROR1</a:t>
            </a:r>
            <a:endParaRPr lang="en-US" altLang="zh-CN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EB403A3-D187-AF44-93AC-9E3BB9F19E2E}"/>
              </a:ext>
            </a:extLst>
          </p:cNvPr>
          <p:cNvSpPr txBox="1"/>
          <p:nvPr>
            <p:custDataLst>
              <p:tags r:id="rId4"/>
            </p:custDataLst>
          </p:nvPr>
        </p:nvSpPr>
        <p:spPr>
          <a:xfrm>
            <a:off x="21624" y="2521028"/>
            <a:ext cx="7422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</a:p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44kDa</a:t>
            </a:r>
          </a:p>
        </p:txBody>
      </p:sp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EEDCF348-A77B-FD7A-4302-94DE3C9262EA}"/>
              </a:ext>
            </a:extLst>
          </p:cNvPr>
          <p:cNvCxnSpPr/>
          <p:nvPr/>
        </p:nvCxnSpPr>
        <p:spPr>
          <a:xfrm>
            <a:off x="763855" y="2782638"/>
            <a:ext cx="415636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E5FA8137-938C-7248-6924-544374E354B8}"/>
              </a:ext>
            </a:extLst>
          </p:cNvPr>
          <p:cNvSpPr txBox="1"/>
          <p:nvPr>
            <p:custDataLst>
              <p:tags r:id="rId5"/>
            </p:custDataLst>
          </p:nvPr>
        </p:nvSpPr>
        <p:spPr>
          <a:xfrm>
            <a:off x="5828627" y="2651649"/>
            <a:ext cx="7422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44kDa</a:t>
            </a:r>
          </a:p>
        </p:txBody>
      </p:sp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EC948A10-C4D5-32D0-2990-4D15A40F6724}"/>
              </a:ext>
            </a:extLst>
          </p:cNvPr>
          <p:cNvCxnSpPr/>
          <p:nvPr/>
        </p:nvCxnSpPr>
        <p:spPr>
          <a:xfrm>
            <a:off x="6570858" y="2913259"/>
            <a:ext cx="415636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5814C0C0-9C62-15F7-092A-E3171B817015}"/>
              </a:ext>
            </a:extLst>
          </p:cNvPr>
          <p:cNvSpPr txBox="1"/>
          <p:nvPr>
            <p:custDataLst>
              <p:tags r:id="rId6"/>
            </p:custDataLst>
          </p:nvPr>
        </p:nvSpPr>
        <p:spPr>
          <a:xfrm rot="18420000">
            <a:off x="7627200" y="584827"/>
            <a:ext cx="915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EC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30F5A08-DD8C-70A4-FBB3-24B67B706B41}"/>
              </a:ext>
            </a:extLst>
          </p:cNvPr>
          <p:cNvSpPr txBox="1"/>
          <p:nvPr>
            <p:custDataLst>
              <p:tags r:id="rId7"/>
            </p:custDataLst>
          </p:nvPr>
        </p:nvSpPr>
        <p:spPr>
          <a:xfrm rot="18420000">
            <a:off x="7817410" y="168218"/>
            <a:ext cx="19589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EC1-ROR1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V3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E5C43AD-3196-6773-5E13-2562102490B1}"/>
              </a:ext>
            </a:extLst>
          </p:cNvPr>
          <p:cNvSpPr txBox="1"/>
          <p:nvPr>
            <p:custDataLst>
              <p:tags r:id="rId8"/>
            </p:custDataLst>
          </p:nvPr>
        </p:nvSpPr>
        <p:spPr>
          <a:xfrm rot="18420000">
            <a:off x="8360763" y="373475"/>
            <a:ext cx="1550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EC1-ROR1</a:t>
            </a:r>
            <a:endParaRPr lang="en-US" altLang="zh-CN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图片 16" descr="jiexian 2023-06-16 14h33m36s(Composite)">
            <a:extLst>
              <a:ext uri="{FF2B5EF4-FFF2-40B4-BE49-F238E27FC236}">
                <a16:creationId xmlns:a16="http://schemas.microsoft.com/office/drawing/2014/main" id="{14E44CEE-A7EB-CE09-F9C8-345B8745962D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l="35894" t="31658" r="45044" b="28117"/>
          <a:stretch/>
        </p:blipFill>
        <p:spPr>
          <a:xfrm>
            <a:off x="2379744" y="4489931"/>
            <a:ext cx="2149475" cy="2328199"/>
          </a:xfrm>
          <a:prstGeom prst="rect">
            <a:avLst/>
          </a:prstGeom>
        </p:spPr>
      </p:pic>
      <p:pic>
        <p:nvPicPr>
          <p:cNvPr id="18" name="图片 17" descr="jiexian 2023-06-16 14h23m26s(Composite)">
            <a:extLst>
              <a:ext uri="{FF2B5EF4-FFF2-40B4-BE49-F238E27FC236}">
                <a16:creationId xmlns:a16="http://schemas.microsoft.com/office/drawing/2014/main" id="{861313D4-8300-B0BD-BAB8-B5AE43AC64D1}"/>
              </a:ext>
            </a:extLst>
          </p:cNvPr>
          <p:cNvPicPr>
            <a:picLocks noChangeAspect="1"/>
          </p:cNvPicPr>
          <p:nvPr/>
        </p:nvPicPr>
        <p:blipFill rotWithShape="1">
          <a:blip r:embed="rId21"/>
          <a:srcRect l="37619" t="29649" r="44184" b="32798"/>
          <a:stretch/>
        </p:blipFill>
        <p:spPr>
          <a:xfrm>
            <a:off x="7144928" y="4423727"/>
            <a:ext cx="2223135" cy="2328197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C1906F40-01BF-BA29-1E08-F5C79CCB7A4B}"/>
              </a:ext>
            </a:extLst>
          </p:cNvPr>
          <p:cNvSpPr txBox="1"/>
          <p:nvPr>
            <p:custDataLst>
              <p:tags r:id="rId9"/>
            </p:custDataLst>
          </p:nvPr>
        </p:nvSpPr>
        <p:spPr>
          <a:xfrm>
            <a:off x="4764112" y="4765991"/>
            <a:ext cx="81224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OR1</a:t>
            </a:r>
          </a:p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35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8C85BC0B-80FB-A5E7-4076-3F5960061183}"/>
              </a:ext>
            </a:extLst>
          </p:cNvPr>
          <p:cNvSpPr txBox="1"/>
          <p:nvPr>
            <p:custDataLst>
              <p:tags r:id="rId10"/>
            </p:custDataLst>
          </p:nvPr>
        </p:nvSpPr>
        <p:spPr>
          <a:xfrm>
            <a:off x="9745015" y="4596363"/>
            <a:ext cx="81224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OR1</a:t>
            </a:r>
          </a:p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35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008E748D-9C92-28F6-2D1E-6420F4AEB65A}"/>
              </a:ext>
            </a:extLst>
          </p:cNvPr>
          <p:cNvSpPr txBox="1"/>
          <p:nvPr/>
        </p:nvSpPr>
        <p:spPr>
          <a:xfrm>
            <a:off x="9770110" y="1203575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434913A8-90FD-EE51-539C-28E65A77A452}"/>
              </a:ext>
            </a:extLst>
          </p:cNvPr>
          <p:cNvSpPr txBox="1"/>
          <p:nvPr/>
        </p:nvSpPr>
        <p:spPr>
          <a:xfrm>
            <a:off x="9770110" y="1571115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70B0B367-B652-E4AD-22A8-9C320A3E3B53}"/>
              </a:ext>
            </a:extLst>
          </p:cNvPr>
          <p:cNvSpPr txBox="1"/>
          <p:nvPr/>
        </p:nvSpPr>
        <p:spPr>
          <a:xfrm>
            <a:off x="9811211" y="1936353"/>
            <a:ext cx="4184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EEE3D302-1205-39A0-EC7E-D31BF78D905A}"/>
              </a:ext>
            </a:extLst>
          </p:cNvPr>
          <p:cNvSpPr txBox="1"/>
          <p:nvPr/>
        </p:nvSpPr>
        <p:spPr>
          <a:xfrm>
            <a:off x="9821154" y="2273386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A4FD1B4A-1188-A39D-D2F1-F5A35DD174B9}"/>
              </a:ext>
            </a:extLst>
          </p:cNvPr>
          <p:cNvSpPr txBox="1"/>
          <p:nvPr/>
        </p:nvSpPr>
        <p:spPr>
          <a:xfrm>
            <a:off x="9792575" y="2660478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58FFB7F-37F4-9B0E-D725-767BEDF65D4E}"/>
              </a:ext>
            </a:extLst>
          </p:cNvPr>
          <p:cNvSpPr txBox="1"/>
          <p:nvPr/>
        </p:nvSpPr>
        <p:spPr>
          <a:xfrm>
            <a:off x="9811211" y="3123930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A6956C5B-E94A-C461-A0B7-42C0FE2C3187}"/>
              </a:ext>
            </a:extLst>
          </p:cNvPr>
          <p:cNvSpPr txBox="1"/>
          <p:nvPr/>
        </p:nvSpPr>
        <p:spPr>
          <a:xfrm>
            <a:off x="9795524" y="766754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77BEF436-BD6B-D2F4-DB0E-FA29715216A0}"/>
              </a:ext>
            </a:extLst>
          </p:cNvPr>
          <p:cNvSpPr txBox="1"/>
          <p:nvPr/>
        </p:nvSpPr>
        <p:spPr>
          <a:xfrm>
            <a:off x="4572367" y="1012569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BF98D687-E0E5-684D-95FC-26C3EC5F2D9E}"/>
              </a:ext>
            </a:extLst>
          </p:cNvPr>
          <p:cNvSpPr txBox="1"/>
          <p:nvPr/>
        </p:nvSpPr>
        <p:spPr>
          <a:xfrm>
            <a:off x="4575314" y="1234694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4A6E7461-E15F-42EA-6C89-CA80AAA2B8A0}"/>
              </a:ext>
            </a:extLst>
          </p:cNvPr>
          <p:cNvSpPr txBox="1"/>
          <p:nvPr/>
        </p:nvSpPr>
        <p:spPr>
          <a:xfrm>
            <a:off x="4591002" y="1523293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67DCE89A-19FD-0AFF-F2A6-402E042113A5}"/>
              </a:ext>
            </a:extLst>
          </p:cNvPr>
          <p:cNvSpPr txBox="1"/>
          <p:nvPr/>
        </p:nvSpPr>
        <p:spPr>
          <a:xfrm>
            <a:off x="4600736" y="1751348"/>
            <a:ext cx="4184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86B5165C-71AA-C85D-7081-FB8A26055808}"/>
              </a:ext>
            </a:extLst>
          </p:cNvPr>
          <p:cNvSpPr txBox="1"/>
          <p:nvPr/>
        </p:nvSpPr>
        <p:spPr>
          <a:xfrm>
            <a:off x="4611551" y="1963554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B94FFACC-E928-006F-067E-AC29041CA405}"/>
              </a:ext>
            </a:extLst>
          </p:cNvPr>
          <p:cNvSpPr txBox="1"/>
          <p:nvPr/>
        </p:nvSpPr>
        <p:spPr>
          <a:xfrm>
            <a:off x="4611551" y="2254878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7D4F3FFA-5146-4AE1-DF95-CF7A7654FB3A}"/>
              </a:ext>
            </a:extLst>
          </p:cNvPr>
          <p:cNvSpPr txBox="1"/>
          <p:nvPr/>
        </p:nvSpPr>
        <p:spPr>
          <a:xfrm>
            <a:off x="4610827" y="2626776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E97C22E1-F3B7-ACC6-1525-FDB1EC31A002}"/>
              </a:ext>
            </a:extLst>
          </p:cNvPr>
          <p:cNvSpPr txBox="1"/>
          <p:nvPr/>
        </p:nvSpPr>
        <p:spPr>
          <a:xfrm>
            <a:off x="4610827" y="2926553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6392A416-D5D6-AF69-4449-69F8F744ADDB}"/>
              </a:ext>
            </a:extLst>
          </p:cNvPr>
          <p:cNvSpPr txBox="1"/>
          <p:nvPr/>
        </p:nvSpPr>
        <p:spPr>
          <a:xfrm>
            <a:off x="4604659" y="3256487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E9BDFF3A-5B1A-C10B-2C31-F9E1BE2B5715}"/>
              </a:ext>
            </a:extLst>
          </p:cNvPr>
          <p:cNvSpPr txBox="1"/>
          <p:nvPr/>
        </p:nvSpPr>
        <p:spPr>
          <a:xfrm>
            <a:off x="4575315" y="663577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DE20E0DA-50E1-7D5B-8B46-BDDCFEB16658}"/>
              </a:ext>
            </a:extLst>
          </p:cNvPr>
          <p:cNvSpPr txBox="1"/>
          <p:nvPr/>
        </p:nvSpPr>
        <p:spPr>
          <a:xfrm>
            <a:off x="4610827" y="3091520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直接箭头连接符 52">
            <a:extLst>
              <a:ext uri="{FF2B5EF4-FFF2-40B4-BE49-F238E27FC236}">
                <a16:creationId xmlns:a16="http://schemas.microsoft.com/office/drawing/2014/main" id="{B3FC5919-F44A-803A-9D3F-6EE807B50480}"/>
              </a:ext>
            </a:extLst>
          </p:cNvPr>
          <p:cNvCxnSpPr/>
          <p:nvPr/>
        </p:nvCxnSpPr>
        <p:spPr>
          <a:xfrm flipH="1">
            <a:off x="4610827" y="5036594"/>
            <a:ext cx="19722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C543A195-5230-1DCA-D703-E3E658BA2FDA}"/>
              </a:ext>
            </a:extLst>
          </p:cNvPr>
          <p:cNvSpPr txBox="1"/>
          <p:nvPr>
            <p:custDataLst>
              <p:tags r:id="rId11"/>
            </p:custDataLst>
          </p:nvPr>
        </p:nvSpPr>
        <p:spPr>
          <a:xfrm rot="18420000">
            <a:off x="2826524" y="3893910"/>
            <a:ext cx="915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EC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5F8FC08B-A5EF-AD3C-B19C-8CCE9FFFE6E7}"/>
              </a:ext>
            </a:extLst>
          </p:cNvPr>
          <p:cNvSpPr txBox="1"/>
          <p:nvPr>
            <p:custDataLst>
              <p:tags r:id="rId12"/>
            </p:custDataLst>
          </p:nvPr>
        </p:nvSpPr>
        <p:spPr>
          <a:xfrm rot="18420000">
            <a:off x="3016734" y="3477301"/>
            <a:ext cx="19589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EC1-ROR1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V3</a:t>
            </a: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8EAA2294-D45D-799D-9BA8-E83AE765E99C}"/>
              </a:ext>
            </a:extLst>
          </p:cNvPr>
          <p:cNvSpPr txBox="1"/>
          <p:nvPr>
            <p:custDataLst>
              <p:tags r:id="rId13"/>
            </p:custDataLst>
          </p:nvPr>
        </p:nvSpPr>
        <p:spPr>
          <a:xfrm rot="18420000">
            <a:off x="3560087" y="3682558"/>
            <a:ext cx="1550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EC1-ROR1</a:t>
            </a:r>
            <a:endParaRPr lang="en-US" altLang="zh-CN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84E9D123-E59F-8C94-B72C-7A9E492B0CAA}"/>
              </a:ext>
            </a:extLst>
          </p:cNvPr>
          <p:cNvSpPr txBox="1"/>
          <p:nvPr/>
        </p:nvSpPr>
        <p:spPr>
          <a:xfrm>
            <a:off x="1926073" y="4632714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B457A5FE-B558-9798-EB83-3EFB6E42657F}"/>
              </a:ext>
            </a:extLst>
          </p:cNvPr>
          <p:cNvSpPr txBox="1"/>
          <p:nvPr/>
        </p:nvSpPr>
        <p:spPr>
          <a:xfrm>
            <a:off x="1918431" y="4835410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D9305CBB-DB4E-E610-D5EA-682BF1360C25}"/>
              </a:ext>
            </a:extLst>
          </p:cNvPr>
          <p:cNvSpPr txBox="1"/>
          <p:nvPr/>
        </p:nvSpPr>
        <p:spPr>
          <a:xfrm>
            <a:off x="1918431" y="5100898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42523F28-A5EF-2A14-0F0C-745F514D498A}"/>
              </a:ext>
            </a:extLst>
          </p:cNvPr>
          <p:cNvSpPr txBox="1"/>
          <p:nvPr/>
        </p:nvSpPr>
        <p:spPr>
          <a:xfrm>
            <a:off x="1952702" y="5316871"/>
            <a:ext cx="4184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6307ED7E-A5F9-A753-2FEF-288A4075DE46}"/>
              </a:ext>
            </a:extLst>
          </p:cNvPr>
          <p:cNvSpPr txBox="1"/>
          <p:nvPr/>
        </p:nvSpPr>
        <p:spPr>
          <a:xfrm>
            <a:off x="1973260" y="5529630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EF2283B6-12D5-62E8-6003-CF16802EA505}"/>
              </a:ext>
            </a:extLst>
          </p:cNvPr>
          <p:cNvSpPr txBox="1"/>
          <p:nvPr/>
        </p:nvSpPr>
        <p:spPr>
          <a:xfrm>
            <a:off x="1964622" y="5785055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C6ED6447-9794-A537-EEE9-113BF69F250D}"/>
              </a:ext>
            </a:extLst>
          </p:cNvPr>
          <p:cNvSpPr txBox="1"/>
          <p:nvPr/>
        </p:nvSpPr>
        <p:spPr>
          <a:xfrm>
            <a:off x="1963898" y="6088522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75690EA5-9D11-9C33-D3C9-EF72575BD076}"/>
              </a:ext>
            </a:extLst>
          </p:cNvPr>
          <p:cNvSpPr txBox="1"/>
          <p:nvPr/>
        </p:nvSpPr>
        <p:spPr>
          <a:xfrm>
            <a:off x="1963898" y="6323230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57F0B50A-A88C-25C5-E7AC-BA0B99DF8857}"/>
              </a:ext>
            </a:extLst>
          </p:cNvPr>
          <p:cNvSpPr txBox="1"/>
          <p:nvPr/>
        </p:nvSpPr>
        <p:spPr>
          <a:xfrm>
            <a:off x="1957730" y="6653164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D8A33381-C970-8027-67E1-DE2B57B71A2B}"/>
              </a:ext>
            </a:extLst>
          </p:cNvPr>
          <p:cNvSpPr txBox="1"/>
          <p:nvPr/>
        </p:nvSpPr>
        <p:spPr>
          <a:xfrm>
            <a:off x="1928386" y="4114044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9E61E36D-D016-858A-6403-36C9B5FE7140}"/>
              </a:ext>
            </a:extLst>
          </p:cNvPr>
          <p:cNvSpPr txBox="1"/>
          <p:nvPr/>
        </p:nvSpPr>
        <p:spPr>
          <a:xfrm>
            <a:off x="1963898" y="6488197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38A6B247-8409-7ACB-E2E1-E446F5C39A40}"/>
              </a:ext>
            </a:extLst>
          </p:cNvPr>
          <p:cNvSpPr txBox="1"/>
          <p:nvPr/>
        </p:nvSpPr>
        <p:spPr>
          <a:xfrm>
            <a:off x="1935259" y="4417211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9010A52D-9563-5D26-3226-FE9FE8DA3E94}"/>
              </a:ext>
            </a:extLst>
          </p:cNvPr>
          <p:cNvSpPr txBox="1"/>
          <p:nvPr>
            <p:custDataLst>
              <p:tags r:id="rId14"/>
            </p:custDataLst>
          </p:nvPr>
        </p:nvSpPr>
        <p:spPr>
          <a:xfrm rot="18420000">
            <a:off x="7829518" y="3859963"/>
            <a:ext cx="915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EC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4D9A2E26-6902-4F57-95D8-E4213D6BCE74}"/>
              </a:ext>
            </a:extLst>
          </p:cNvPr>
          <p:cNvSpPr txBox="1"/>
          <p:nvPr>
            <p:custDataLst>
              <p:tags r:id="rId15"/>
            </p:custDataLst>
          </p:nvPr>
        </p:nvSpPr>
        <p:spPr>
          <a:xfrm rot="18420000">
            <a:off x="8019728" y="3443354"/>
            <a:ext cx="19589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EC1-ROR1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V3</a:t>
            </a: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DF9494F1-A290-9CBC-0343-B86539F5CF6D}"/>
              </a:ext>
            </a:extLst>
          </p:cNvPr>
          <p:cNvSpPr txBox="1"/>
          <p:nvPr>
            <p:custDataLst>
              <p:tags r:id="rId16"/>
            </p:custDataLst>
          </p:nvPr>
        </p:nvSpPr>
        <p:spPr>
          <a:xfrm rot="18420000">
            <a:off x="8563081" y="3648611"/>
            <a:ext cx="1550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EC1-ROR1</a:t>
            </a:r>
            <a:endParaRPr lang="en-US" altLang="zh-CN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直接箭头连接符 71">
            <a:extLst>
              <a:ext uri="{FF2B5EF4-FFF2-40B4-BE49-F238E27FC236}">
                <a16:creationId xmlns:a16="http://schemas.microsoft.com/office/drawing/2014/main" id="{EC0E1735-5431-DD4F-72A5-B44532BC3658}"/>
              </a:ext>
            </a:extLst>
          </p:cNvPr>
          <p:cNvCxnSpPr/>
          <p:nvPr/>
        </p:nvCxnSpPr>
        <p:spPr>
          <a:xfrm flipH="1">
            <a:off x="9572886" y="4899178"/>
            <a:ext cx="19722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id="{2DF53616-EF5C-D611-CE69-08A4600543D7}"/>
              </a:ext>
            </a:extLst>
          </p:cNvPr>
          <p:cNvSpPr txBox="1"/>
          <p:nvPr/>
        </p:nvSpPr>
        <p:spPr>
          <a:xfrm>
            <a:off x="6609648" y="4417210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7363FF0B-7AA8-B357-BFA8-64CE63BA69FF}"/>
              </a:ext>
            </a:extLst>
          </p:cNvPr>
          <p:cNvSpPr txBox="1"/>
          <p:nvPr/>
        </p:nvSpPr>
        <p:spPr>
          <a:xfrm>
            <a:off x="6618892" y="4638193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A74321A1-4E67-574D-D134-3E19E6B8E88A}"/>
              </a:ext>
            </a:extLst>
          </p:cNvPr>
          <p:cNvSpPr txBox="1"/>
          <p:nvPr/>
        </p:nvSpPr>
        <p:spPr>
          <a:xfrm>
            <a:off x="6625337" y="4861727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7130AF9E-EA5A-B16B-0CC4-8D85D5FD240C}"/>
              </a:ext>
            </a:extLst>
          </p:cNvPr>
          <p:cNvSpPr txBox="1"/>
          <p:nvPr/>
        </p:nvSpPr>
        <p:spPr>
          <a:xfrm>
            <a:off x="6635071" y="5089782"/>
            <a:ext cx="4184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B523F21F-6A64-3BA5-93AF-A21D68C3BBB7}"/>
              </a:ext>
            </a:extLst>
          </p:cNvPr>
          <p:cNvSpPr txBox="1"/>
          <p:nvPr/>
        </p:nvSpPr>
        <p:spPr>
          <a:xfrm>
            <a:off x="6645886" y="5293023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008D2FF5-3D8F-B74F-5FFE-63861DFC5A6D}"/>
              </a:ext>
            </a:extLst>
          </p:cNvPr>
          <p:cNvSpPr txBox="1"/>
          <p:nvPr/>
        </p:nvSpPr>
        <p:spPr>
          <a:xfrm>
            <a:off x="6645886" y="5585168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E9C52BB1-A382-69CC-96C5-A5D0B1582C1A}"/>
              </a:ext>
            </a:extLst>
          </p:cNvPr>
          <p:cNvSpPr txBox="1"/>
          <p:nvPr/>
        </p:nvSpPr>
        <p:spPr>
          <a:xfrm>
            <a:off x="6635071" y="5837739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578FE0FA-2B5D-84BA-0CD1-ABA1A102C74C}"/>
              </a:ext>
            </a:extLst>
          </p:cNvPr>
          <p:cNvSpPr txBox="1"/>
          <p:nvPr/>
        </p:nvSpPr>
        <p:spPr>
          <a:xfrm>
            <a:off x="6644739" y="6141205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FB766871-53C4-9B7C-A29F-C1DD0C85E8E5}"/>
              </a:ext>
            </a:extLst>
          </p:cNvPr>
          <p:cNvSpPr txBox="1"/>
          <p:nvPr/>
        </p:nvSpPr>
        <p:spPr>
          <a:xfrm>
            <a:off x="6635071" y="6435775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E4D8BDD4-85DC-48BD-D4BA-A90FE036CA43}"/>
              </a:ext>
            </a:extLst>
          </p:cNvPr>
          <p:cNvSpPr txBox="1"/>
          <p:nvPr/>
        </p:nvSpPr>
        <p:spPr>
          <a:xfrm>
            <a:off x="6609650" y="4002011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FC6274B8-F271-82D9-DDAB-5533ED4C2FF3}"/>
              </a:ext>
            </a:extLst>
          </p:cNvPr>
          <p:cNvSpPr txBox="1"/>
          <p:nvPr/>
        </p:nvSpPr>
        <p:spPr>
          <a:xfrm>
            <a:off x="6644527" y="6293763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42092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jiexian 2023-06-16 20h05m33s(Composite)">
            <a:extLst>
              <a:ext uri="{FF2B5EF4-FFF2-40B4-BE49-F238E27FC236}">
                <a16:creationId xmlns:a16="http://schemas.microsoft.com/office/drawing/2014/main" id="{22991160-1C7D-6F81-F734-F543C5C00468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l="33019" t="32060" r="49067" b="27069"/>
          <a:stretch>
            <a:fillRect/>
          </a:stretch>
        </p:blipFill>
        <p:spPr>
          <a:xfrm>
            <a:off x="1655224" y="1791945"/>
            <a:ext cx="2042160" cy="2720975"/>
          </a:xfrm>
          <a:prstGeom prst="rect">
            <a:avLst/>
          </a:prstGeom>
        </p:spPr>
      </p:pic>
      <p:pic>
        <p:nvPicPr>
          <p:cNvPr id="6" name="图片 5" descr="jiexian 2023-06-16 19h58m04s(Composite)">
            <a:extLst>
              <a:ext uri="{FF2B5EF4-FFF2-40B4-BE49-F238E27FC236}">
                <a16:creationId xmlns:a16="http://schemas.microsoft.com/office/drawing/2014/main" id="{34AA5508-0F3A-2938-D6FE-33423FF1AD5E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30933" t="28795" r="50597" b="34317"/>
          <a:stretch/>
        </p:blipFill>
        <p:spPr>
          <a:xfrm>
            <a:off x="7795593" y="1934714"/>
            <a:ext cx="2373630" cy="2578204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28E6726C-710B-21E2-FC55-EDD90FAE9E07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>
            <a:off x="4128573" y="2990595"/>
            <a:ext cx="79232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E98E0D5D-A976-7664-3E8C-F245B3EEE27F}"/>
              </a:ext>
            </a:extLst>
          </p:cNvPr>
          <p:cNvSpPr txBox="1"/>
          <p:nvPr>
            <p:custDataLst>
              <p:tags r:id="rId2"/>
            </p:custDataLst>
          </p:nvPr>
        </p:nvSpPr>
        <p:spPr>
          <a:xfrm>
            <a:off x="10480011" y="3314944"/>
            <a:ext cx="79232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9458720E-F4B7-86DF-5FE4-686C6DA32998}"/>
              </a:ext>
            </a:extLst>
          </p:cNvPr>
          <p:cNvSpPr txBox="1"/>
          <p:nvPr>
            <p:custDataLst>
              <p:tags r:id="rId3"/>
            </p:custDataLst>
          </p:nvPr>
        </p:nvSpPr>
        <p:spPr>
          <a:xfrm rot="18420000">
            <a:off x="2030165" y="1137586"/>
            <a:ext cx="9156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EC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DA1DDA7-5D24-B663-E414-820A576DA59C}"/>
              </a:ext>
            </a:extLst>
          </p:cNvPr>
          <p:cNvSpPr txBox="1"/>
          <p:nvPr>
            <p:custDataLst>
              <p:tags r:id="rId4"/>
            </p:custDataLst>
          </p:nvPr>
        </p:nvSpPr>
        <p:spPr>
          <a:xfrm rot="18420000">
            <a:off x="2220375" y="720977"/>
            <a:ext cx="19589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EC1-ROR1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V3</a:t>
            </a: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6768E2A-4379-8574-E410-91D77921B2ED}"/>
              </a:ext>
            </a:extLst>
          </p:cNvPr>
          <p:cNvSpPr txBox="1"/>
          <p:nvPr>
            <p:custDataLst>
              <p:tags r:id="rId5"/>
            </p:custDataLst>
          </p:nvPr>
        </p:nvSpPr>
        <p:spPr>
          <a:xfrm rot="18420000">
            <a:off x="2763728" y="926234"/>
            <a:ext cx="15506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EC1-ROR1</a:t>
            </a:r>
            <a:endParaRPr lang="en-US" altLang="zh-CN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AD3B22E-D9C6-322E-E911-8C17BB5D1AD2}"/>
              </a:ext>
            </a:extLst>
          </p:cNvPr>
          <p:cNvSpPr txBox="1"/>
          <p:nvPr>
            <p:custDataLst>
              <p:tags r:id="rId6"/>
            </p:custDataLst>
          </p:nvPr>
        </p:nvSpPr>
        <p:spPr>
          <a:xfrm rot="18420000">
            <a:off x="8593535" y="1171240"/>
            <a:ext cx="9156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EC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DD4EF22F-C0F4-E51F-B1E5-34E9274EEF0E}"/>
              </a:ext>
            </a:extLst>
          </p:cNvPr>
          <p:cNvSpPr txBox="1"/>
          <p:nvPr>
            <p:custDataLst>
              <p:tags r:id="rId7"/>
            </p:custDataLst>
          </p:nvPr>
        </p:nvSpPr>
        <p:spPr>
          <a:xfrm rot="18420000">
            <a:off x="8784253" y="796845"/>
            <a:ext cx="19589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EC1-ROR1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V3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61683F5-36BD-ED1E-1679-5852C1922EEF}"/>
              </a:ext>
            </a:extLst>
          </p:cNvPr>
          <p:cNvSpPr txBox="1"/>
          <p:nvPr>
            <p:custDataLst>
              <p:tags r:id="rId8"/>
            </p:custDataLst>
          </p:nvPr>
        </p:nvSpPr>
        <p:spPr>
          <a:xfrm rot="18420000">
            <a:off x="9327098" y="959888"/>
            <a:ext cx="15506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EC1-ROR1</a:t>
            </a:r>
            <a:endParaRPr lang="en-US" altLang="zh-CN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直接箭头连接符 2">
            <a:extLst>
              <a:ext uri="{FF2B5EF4-FFF2-40B4-BE49-F238E27FC236}">
                <a16:creationId xmlns:a16="http://schemas.microsoft.com/office/drawing/2014/main" id="{E04CFA7C-0C59-2330-CB38-CF43BF418FE8}"/>
              </a:ext>
            </a:extLst>
          </p:cNvPr>
          <p:cNvCxnSpPr/>
          <p:nvPr/>
        </p:nvCxnSpPr>
        <p:spPr>
          <a:xfrm flipH="1">
            <a:off x="3836894" y="3242206"/>
            <a:ext cx="19722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" name="文本框 4">
            <a:extLst>
              <a:ext uri="{FF2B5EF4-FFF2-40B4-BE49-F238E27FC236}">
                <a16:creationId xmlns:a16="http://schemas.microsoft.com/office/drawing/2014/main" id="{7A0064D1-3D77-B93E-CFA6-EBB1556C7B1C}"/>
              </a:ext>
            </a:extLst>
          </p:cNvPr>
          <p:cNvSpPr txBox="1"/>
          <p:nvPr/>
        </p:nvSpPr>
        <p:spPr>
          <a:xfrm>
            <a:off x="1055795" y="1825600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E9DD95E8-1F1B-6611-2F3A-7D71F3215CB9}"/>
              </a:ext>
            </a:extLst>
          </p:cNvPr>
          <p:cNvSpPr txBox="1"/>
          <p:nvPr/>
        </p:nvSpPr>
        <p:spPr>
          <a:xfrm>
            <a:off x="1055795" y="2102599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E2337CEE-7ABD-53AC-4568-1538A29EE3C2}"/>
              </a:ext>
            </a:extLst>
          </p:cNvPr>
          <p:cNvSpPr txBox="1"/>
          <p:nvPr/>
        </p:nvSpPr>
        <p:spPr>
          <a:xfrm>
            <a:off x="1068871" y="2362523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8DFFD690-AB60-F14A-7C99-D48D0287E80C}"/>
              </a:ext>
            </a:extLst>
          </p:cNvPr>
          <p:cNvSpPr txBox="1"/>
          <p:nvPr/>
        </p:nvSpPr>
        <p:spPr>
          <a:xfrm>
            <a:off x="1062014" y="2639522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BA8DEC22-1A1A-7293-6763-FA301C2DBB6C}"/>
              </a:ext>
            </a:extLst>
          </p:cNvPr>
          <p:cNvSpPr txBox="1"/>
          <p:nvPr/>
        </p:nvSpPr>
        <p:spPr>
          <a:xfrm>
            <a:off x="1077740" y="2892261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815A346-A574-9B8A-E5B8-76A5043AD334}"/>
              </a:ext>
            </a:extLst>
          </p:cNvPr>
          <p:cNvSpPr txBox="1"/>
          <p:nvPr/>
        </p:nvSpPr>
        <p:spPr>
          <a:xfrm>
            <a:off x="1055141" y="3176445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67BF191-48CF-C27B-D31E-8889DFE65DA3}"/>
              </a:ext>
            </a:extLst>
          </p:cNvPr>
          <p:cNvSpPr txBox="1"/>
          <p:nvPr/>
        </p:nvSpPr>
        <p:spPr>
          <a:xfrm>
            <a:off x="1058744" y="3493888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3901C941-8C18-9314-23F2-1DAE246EAC0E}"/>
              </a:ext>
            </a:extLst>
          </p:cNvPr>
          <p:cNvSpPr txBox="1"/>
          <p:nvPr/>
        </p:nvSpPr>
        <p:spPr>
          <a:xfrm>
            <a:off x="1056506" y="3804993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2FAE62AC-6CC3-59D4-95D4-90FE2A110BAB}"/>
              </a:ext>
            </a:extLst>
          </p:cNvPr>
          <p:cNvSpPr txBox="1"/>
          <p:nvPr/>
        </p:nvSpPr>
        <p:spPr>
          <a:xfrm>
            <a:off x="1054268" y="3943492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0FAF0556-C52A-81B0-210A-7CD9A28B820C}"/>
              </a:ext>
            </a:extLst>
          </p:cNvPr>
          <p:cNvSpPr txBox="1"/>
          <p:nvPr/>
        </p:nvSpPr>
        <p:spPr>
          <a:xfrm>
            <a:off x="1051443" y="4100865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1B0E9B2D-3937-065A-EA82-4DA46C7F1B38}"/>
              </a:ext>
            </a:extLst>
          </p:cNvPr>
          <p:cNvSpPr txBox="1"/>
          <p:nvPr/>
        </p:nvSpPr>
        <p:spPr>
          <a:xfrm>
            <a:off x="1058743" y="1449713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接箭头连接符 26">
            <a:extLst>
              <a:ext uri="{FF2B5EF4-FFF2-40B4-BE49-F238E27FC236}">
                <a16:creationId xmlns:a16="http://schemas.microsoft.com/office/drawing/2014/main" id="{6204038C-926F-D993-2FD9-5A6A663ED2D4}"/>
              </a:ext>
            </a:extLst>
          </p:cNvPr>
          <p:cNvCxnSpPr/>
          <p:nvPr/>
        </p:nvCxnSpPr>
        <p:spPr>
          <a:xfrm flipH="1">
            <a:off x="10282787" y="3611440"/>
            <a:ext cx="19722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id="{9B79431F-3F0A-2E88-2FE2-B0FE947F7EB2}"/>
              </a:ext>
            </a:extLst>
          </p:cNvPr>
          <p:cNvSpPr txBox="1"/>
          <p:nvPr/>
        </p:nvSpPr>
        <p:spPr>
          <a:xfrm>
            <a:off x="7162781" y="2033602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5166530E-311D-0F25-0ADD-05A347D05372}"/>
              </a:ext>
            </a:extLst>
          </p:cNvPr>
          <p:cNvSpPr txBox="1"/>
          <p:nvPr/>
        </p:nvSpPr>
        <p:spPr>
          <a:xfrm>
            <a:off x="7165728" y="2264692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248489DC-42F2-550A-34A8-6F81D350DBCB}"/>
              </a:ext>
            </a:extLst>
          </p:cNvPr>
          <p:cNvSpPr txBox="1"/>
          <p:nvPr/>
        </p:nvSpPr>
        <p:spPr>
          <a:xfrm>
            <a:off x="7181416" y="2517431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8FC1BB3B-31B0-E696-370F-46AFAF4FD7F1}"/>
              </a:ext>
            </a:extLst>
          </p:cNvPr>
          <p:cNvSpPr txBox="1"/>
          <p:nvPr/>
        </p:nvSpPr>
        <p:spPr>
          <a:xfrm>
            <a:off x="7191150" y="2745486"/>
            <a:ext cx="4184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F834EEF7-0ECB-4116-4D06-12C83347BC99}"/>
              </a:ext>
            </a:extLst>
          </p:cNvPr>
          <p:cNvSpPr txBox="1"/>
          <p:nvPr/>
        </p:nvSpPr>
        <p:spPr>
          <a:xfrm>
            <a:off x="7201965" y="2948727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137602E4-374D-FBA3-53CF-D4B7E3346ECB}"/>
              </a:ext>
            </a:extLst>
          </p:cNvPr>
          <p:cNvSpPr txBox="1"/>
          <p:nvPr/>
        </p:nvSpPr>
        <p:spPr>
          <a:xfrm>
            <a:off x="7201965" y="3195226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105E4F23-DD26-8F9D-1EB6-8E8326CF1478}"/>
              </a:ext>
            </a:extLst>
          </p:cNvPr>
          <p:cNvSpPr txBox="1"/>
          <p:nvPr/>
        </p:nvSpPr>
        <p:spPr>
          <a:xfrm>
            <a:off x="7201241" y="3522302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0F9F1C7C-5958-7418-07B0-FE0C045FB426}"/>
              </a:ext>
            </a:extLst>
          </p:cNvPr>
          <p:cNvSpPr txBox="1"/>
          <p:nvPr/>
        </p:nvSpPr>
        <p:spPr>
          <a:xfrm>
            <a:off x="7201241" y="3866901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B74E5591-AA05-E3E2-64C0-5666C11E193F}"/>
              </a:ext>
            </a:extLst>
          </p:cNvPr>
          <p:cNvSpPr txBox="1"/>
          <p:nvPr/>
        </p:nvSpPr>
        <p:spPr>
          <a:xfrm>
            <a:off x="7195073" y="4196835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84AE03E7-45EA-FDB8-6A28-8BCBD1DA07DB}"/>
              </a:ext>
            </a:extLst>
          </p:cNvPr>
          <p:cNvSpPr txBox="1"/>
          <p:nvPr/>
        </p:nvSpPr>
        <p:spPr>
          <a:xfrm>
            <a:off x="7165729" y="1657715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C20EABB3-D884-18BE-A243-38177199D0B7}"/>
              </a:ext>
            </a:extLst>
          </p:cNvPr>
          <p:cNvSpPr txBox="1"/>
          <p:nvPr/>
        </p:nvSpPr>
        <p:spPr>
          <a:xfrm>
            <a:off x="7201241" y="4031868"/>
            <a:ext cx="500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72443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D4D724D8-1108-4525-A22A-F9F283D9CBF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3772316"/>
              </p:ext>
            </p:extLst>
          </p:nvPr>
        </p:nvGraphicFramePr>
        <p:xfrm>
          <a:off x="672355" y="1896501"/>
          <a:ext cx="10847290" cy="306499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321859">
                  <a:extLst>
                    <a:ext uri="{9D8B030D-6E8A-4147-A177-3AD203B41FA5}">
                      <a16:colId xmlns:a16="http://schemas.microsoft.com/office/drawing/2014/main" val="3510791637"/>
                    </a:ext>
                  </a:extLst>
                </a:gridCol>
                <a:gridCol w="2017057">
                  <a:extLst>
                    <a:ext uri="{9D8B030D-6E8A-4147-A177-3AD203B41FA5}">
                      <a16:colId xmlns:a16="http://schemas.microsoft.com/office/drawing/2014/main" val="3149612224"/>
                    </a:ext>
                  </a:extLst>
                </a:gridCol>
                <a:gridCol w="1434355">
                  <a:extLst>
                    <a:ext uri="{9D8B030D-6E8A-4147-A177-3AD203B41FA5}">
                      <a16:colId xmlns:a16="http://schemas.microsoft.com/office/drawing/2014/main" val="4214013675"/>
                    </a:ext>
                  </a:extLst>
                </a:gridCol>
                <a:gridCol w="3101789">
                  <a:extLst>
                    <a:ext uri="{9D8B030D-6E8A-4147-A177-3AD203B41FA5}">
                      <a16:colId xmlns:a16="http://schemas.microsoft.com/office/drawing/2014/main" val="2505357371"/>
                    </a:ext>
                  </a:extLst>
                </a:gridCol>
                <a:gridCol w="1972230">
                  <a:extLst>
                    <a:ext uri="{9D8B030D-6E8A-4147-A177-3AD203B41FA5}">
                      <a16:colId xmlns:a16="http://schemas.microsoft.com/office/drawing/2014/main" val="1928577812"/>
                    </a:ext>
                  </a:extLst>
                </a:gridCol>
              </a:tblGrid>
              <a:tr h="532267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Antibody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conjugate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Clone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Source 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dilution</a:t>
                      </a:r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58123275"/>
                  </a:ext>
                </a:extLst>
              </a:tr>
              <a:tr h="720303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Anti-human ROR1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Alexa Fluor 647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4A5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Homemade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1:100</a:t>
                      </a:r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90084491"/>
                  </a:ext>
                </a:extLst>
              </a:tr>
              <a:tr h="125880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Anti-human ROR1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dirty="0"/>
                        <a:t>Alexa Fluor 647</a:t>
                      </a:r>
                      <a:endParaRPr lang="zh-CN" altLang="en-US" dirty="0"/>
                    </a:p>
                    <a:p>
                      <a:pPr algn="ctr"/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UC-961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Homemade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1:100</a:t>
                      </a:r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90585642"/>
                  </a:ext>
                </a:extLst>
              </a:tr>
              <a:tr h="354766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Anti-human ERK1/2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dirty="0"/>
                        <a:t>Alexa Fluor 488</a:t>
                      </a:r>
                      <a:endParaRPr lang="zh-CN" altLang="en-US" dirty="0"/>
                    </a:p>
                    <a:p>
                      <a:pPr algn="ctr"/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197G2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Cell Signaling Technology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1:50</a:t>
                      </a:r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82549439"/>
                  </a:ext>
                </a:extLst>
              </a:tr>
              <a:tr h="532267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Anti-mouse pERK1/2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dirty="0"/>
                        <a:t>Alexa Fluor 647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E1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dirty="0"/>
                        <a:t>Cell Signaling Technology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1:50</a:t>
                      </a:r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91631070"/>
                  </a:ext>
                </a:extLst>
              </a:tr>
            </a:tbl>
          </a:graphicData>
        </a:graphic>
      </p:graphicFrame>
      <p:sp>
        <p:nvSpPr>
          <p:cNvPr id="5" name="标题 1">
            <a:extLst>
              <a:ext uri="{FF2B5EF4-FFF2-40B4-BE49-F238E27FC236}">
                <a16:creationId xmlns:a16="http://schemas.microsoft.com/office/drawing/2014/main" id="{DAB1AE6E-FC32-EB26-22D6-FE5E7282C1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/>
          <a:lstStyle/>
          <a:p>
            <a:r>
              <a:rPr lang="en-US" altLang="zh-CN" dirty="0"/>
              <a:t>Antibodies used for FAC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106125864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138</Words>
  <Application>Microsoft Office PowerPoint</Application>
  <PresentationFormat>Widescreen</PresentationFormat>
  <Paragraphs>11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等线</vt:lpstr>
      <vt:lpstr>等线 Light</vt:lpstr>
      <vt:lpstr>Office 主题​​</vt:lpstr>
      <vt:lpstr>PowerPoint Presentation</vt:lpstr>
      <vt:lpstr>PowerPoint Presentation</vt:lpstr>
      <vt:lpstr>Antibodies used for FAC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e Xian</dc:creator>
  <cp:lastModifiedBy>Lipski, Beth</cp:lastModifiedBy>
  <cp:revision>3</cp:revision>
  <dcterms:created xsi:type="dcterms:W3CDTF">2024-07-03T00:57:06Z</dcterms:created>
  <dcterms:modified xsi:type="dcterms:W3CDTF">2024-07-09T22:14:54Z</dcterms:modified>
</cp:coreProperties>
</file>